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6858000" cy="9906000" type="A4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31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4649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4088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3901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672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0907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863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1893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142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8105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5569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1382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E87E4-A4F1-4998-A60D-9631FC8B1D8B}" type="datetimeFigureOut">
              <a:rPr lang="zh-CN" altLang="en-US" smtClean="0"/>
              <a:t>2019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1C558-C786-496F-A25D-27BD1DA5B5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351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24444" y="5392732"/>
            <a:ext cx="41889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gel images of Fig. 3</a:t>
            </a:r>
            <a:r>
              <a:rPr lang="en-US" altLang="zh-CN" sz="2000" b="1" dirty="0" smtClean="0"/>
              <a:t>f</a:t>
            </a:r>
            <a:r>
              <a:rPr lang="en-US" altLang="zh-CN" sz="2000" b="1" dirty="0" smtClean="0"/>
              <a:t>.</a:t>
            </a:r>
            <a:endParaRPr lang="zh-CN" altLang="en-US" sz="2000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444" y="157623"/>
            <a:ext cx="6411134" cy="5123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1869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568" y="529977"/>
            <a:ext cx="6549080" cy="4914793"/>
          </a:xfrm>
        </p:spPr>
      </p:pic>
      <p:sp>
        <p:nvSpPr>
          <p:cNvPr id="5" name="矩形 4"/>
          <p:cNvSpPr/>
          <p:nvPr/>
        </p:nvSpPr>
        <p:spPr>
          <a:xfrm>
            <a:off x="123568" y="5615154"/>
            <a:ext cx="526397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Western blot images of Fig. 3h.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8181354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6046"/>
            <a:ext cx="6858000" cy="534446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24444" y="5059100"/>
            <a:ext cx="41889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gel images of Fig. 6e.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0407140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5650"/>
            <a:ext cx="6858000" cy="5480538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87374" y="5876827"/>
            <a:ext cx="41889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gel images of Fig. 6</a:t>
            </a:r>
            <a:r>
              <a:rPr lang="en-US" altLang="zh-CN" sz="2000" b="1" dirty="0" smtClean="0"/>
              <a:t>f</a:t>
            </a:r>
            <a:r>
              <a:rPr lang="en-US" altLang="zh-CN" sz="2000" b="1" dirty="0" smtClean="0"/>
              <a:t>.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3273695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845" y="3476097"/>
            <a:ext cx="6395879" cy="5122271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32" y="304386"/>
            <a:ext cx="5387546" cy="429450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932935" y="8969071"/>
            <a:ext cx="41889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gel images of Fig. 6</a:t>
            </a:r>
            <a:r>
              <a:rPr lang="en-US" altLang="zh-CN" sz="2000" b="1" dirty="0" smtClean="0"/>
              <a:t>g</a:t>
            </a:r>
            <a:r>
              <a:rPr lang="en-US" altLang="zh-CN" sz="2000" b="1" dirty="0" smtClean="0"/>
              <a:t>.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8386863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837" y="0"/>
            <a:ext cx="5412260" cy="431421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1" y="4187700"/>
            <a:ext cx="6116594" cy="4907886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932935" y="9095586"/>
            <a:ext cx="41889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gel images of Fig. 6h</a:t>
            </a:r>
            <a:r>
              <a:rPr lang="en-US" altLang="zh-CN" sz="2000" b="1" dirty="0"/>
              <a:t>.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3536533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07" y="252861"/>
            <a:ext cx="6607107" cy="5245896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27454" y="4622440"/>
            <a:ext cx="41889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 smtClean="0"/>
              <a:t>Uncropped gel images of Fig. 6i.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5385181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57</Words>
  <Application>Microsoft Office PowerPoint</Application>
  <PresentationFormat>A4 纸张(210x297 毫米)</PresentationFormat>
  <Paragraphs>7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5</cp:revision>
  <dcterms:created xsi:type="dcterms:W3CDTF">2019-04-16T03:02:58Z</dcterms:created>
  <dcterms:modified xsi:type="dcterms:W3CDTF">2019-04-16T03:39:17Z</dcterms:modified>
</cp:coreProperties>
</file>